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B5A47-6B84-4B07-AE29-B27C8CD117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9215B-2A65-488A-97D4-2AC0168613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EE092-B224-4D24-8796-35AF8B5CCC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A2D52-940C-4177-ABA6-B485763D9C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D59E5-6DAF-4C5D-9858-15D58361CE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AD4EB-ECF6-4E2A-9B1D-EAFBCE7C0C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C8948-DCF1-4F10-B465-1E0EE55325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BDFC3-6093-4763-A59C-68AAA2BDF7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3A474-7F2A-43AB-BFF1-0E5B84B220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4CECE-1783-4591-8517-B8EB12B21C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9AECD-A5B6-4EAC-A187-12A4715EE8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73C11-388C-4A19-A747-4F6BD94A77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E1AD7F-03BB-4145-8AEC-328F69BBA2D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923280" y="6148440"/>
            <a:ext cx="1273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Emys_orbicular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20400" y="59389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D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920400" y="57420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K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934800" y="55339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K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920400" y="53355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D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934800" y="51274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G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960000" y="49291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G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960000" y="472140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J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960360" y="451152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I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972600" y="431496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J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973320" y="410544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I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934440" y="390852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F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934440" y="370044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F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935160" y="350208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E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935160" y="329400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E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908160" y="308448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L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907800" y="28875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H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920760" y="26780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L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920400" y="24811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H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775680" y="227340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C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775680" y="20620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C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670560" y="1866960"/>
            <a:ext cx="1256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Chrysemys_pic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894840" y="16556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N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867840" y="146052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M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348800" y="1249200"/>
            <a:ext cx="1355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Trachemys_scrip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880800" y="10540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N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880440" y="84312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3M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881520" y="6235560"/>
            <a:ext cx="140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881520" y="6026040"/>
            <a:ext cx="140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3881520" y="6026040"/>
            <a:ext cx="144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881520" y="61372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881520" y="58294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3881520" y="5829120"/>
            <a:ext cx="1440" cy="30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881520" y="59770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881520" y="5619600"/>
            <a:ext cx="270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3881520" y="5619240"/>
            <a:ext cx="1440" cy="35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881520" y="580536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881520" y="542304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3881520" y="5423040"/>
            <a:ext cx="1440" cy="38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908520" y="521352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908520" y="5016600"/>
            <a:ext cx="12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3908520" y="5016240"/>
            <a:ext cx="3240" cy="19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881520" y="560700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881520" y="5113440"/>
            <a:ext cx="270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3881520" y="5113080"/>
            <a:ext cx="1440" cy="493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921120" y="4807080"/>
            <a:ext cx="14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921120" y="4597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3921120" y="4597560"/>
            <a:ext cx="144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948120" y="440208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948120" y="419256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3948120" y="4192560"/>
            <a:ext cx="324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921120" y="470844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921120" y="4302000"/>
            <a:ext cx="27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3921120" y="4301640"/>
            <a:ext cx="1440" cy="406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908520" y="358920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908520" y="337968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3908520" y="3379680"/>
            <a:ext cx="324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908520" y="37861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908520" y="34783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3908520" y="3477960"/>
            <a:ext cx="3240" cy="30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908520" y="399564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908520" y="36385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3908520" y="3638520"/>
            <a:ext cx="3240" cy="35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868560" y="4498920"/>
            <a:ext cx="525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868560" y="3809880"/>
            <a:ext cx="399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3868560" y="3809880"/>
            <a:ext cx="3240" cy="689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827520" y="5361120"/>
            <a:ext cx="5400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827520" y="4156200"/>
            <a:ext cx="41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3827520" y="4155840"/>
            <a:ext cx="1440" cy="12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868560" y="317016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868560" y="297504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3868560" y="2975040"/>
            <a:ext cx="3240" cy="19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895560" y="2763720"/>
            <a:ext cx="1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895560" y="256860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3895560" y="2568600"/>
            <a:ext cx="1800" cy="19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868560" y="307188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868560" y="2665440"/>
            <a:ext cx="270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flipV="1">
            <a:off x="3868560" y="2665080"/>
            <a:ext cx="3240" cy="406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827520" y="47577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827520" y="2863800"/>
            <a:ext cx="410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flipV="1">
            <a:off x="3827520" y="2863440"/>
            <a:ext cx="1440" cy="1893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747960" y="235728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747960" y="21495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3747960" y="2149200"/>
            <a:ext cx="3240" cy="207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697200" y="3809880"/>
            <a:ext cx="1303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697200" y="2259000"/>
            <a:ext cx="507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3697200" y="2259000"/>
            <a:ext cx="1800" cy="155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841920" y="1743120"/>
            <a:ext cx="14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841920" y="15447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V="1">
            <a:off x="3841920" y="154440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827520" y="1138320"/>
            <a:ext cx="144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827520" y="930240"/>
            <a:ext cx="14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3827520" y="930240"/>
            <a:ext cx="1440" cy="208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816360" y="1336680"/>
            <a:ext cx="488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816360" y="1027080"/>
            <a:ext cx="111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3816360" y="1027080"/>
            <a:ext cx="1440" cy="30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801960" y="1644480"/>
            <a:ext cx="39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801960" y="1189080"/>
            <a:ext cx="14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V="1">
            <a:off x="3801960" y="1188720"/>
            <a:ext cx="1800" cy="455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2575080" y="1951200"/>
            <a:ext cx="1068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575080" y="1409760"/>
            <a:ext cx="12268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V="1">
            <a:off x="2575080" y="1409760"/>
            <a:ext cx="1440" cy="54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071800" y="3035160"/>
            <a:ext cx="1625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071800" y="1681200"/>
            <a:ext cx="5032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2071800" y="1680840"/>
            <a:ext cx="1440" cy="1353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6" name=""/>
          <p:cNvGrpSpPr/>
          <p:nvPr/>
        </p:nvGrpSpPr>
        <p:grpSpPr>
          <a:xfrm>
            <a:off x="1763640" y="5734080"/>
            <a:ext cx="544680" cy="333360"/>
            <a:chOff x="1763640" y="5734080"/>
            <a:chExt cx="544680" cy="333360"/>
          </a:xfrm>
        </p:grpSpPr>
        <p:sp>
          <p:nvSpPr>
            <p:cNvPr id="147" name=""/>
            <p:cNvSpPr/>
            <p:nvPr/>
          </p:nvSpPr>
          <p:spPr>
            <a:xfrm>
              <a:off x="1763640" y="6018120"/>
              <a:ext cx="5428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1763640" y="5968800"/>
              <a:ext cx="1800" cy="9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2306520" y="5968800"/>
              <a:ext cx="1800" cy="9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885320" y="57340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1" name=""/>
          <p:cNvSpPr/>
          <p:nvPr/>
        </p:nvSpPr>
        <p:spPr>
          <a:xfrm>
            <a:off x="6374520" y="1123920"/>
            <a:ext cx="204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Trachemys scrip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6084720" y="836640"/>
            <a:ext cx="0" cy="9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5940360" y="17715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940360" y="836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448320" y="386064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Emys orbicular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6084720" y="2060640"/>
            <a:ext cx="0" cy="424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5940360" y="6308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5940360" y="2060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97080" y="3333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2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"/>
          <p:cNvSpPr/>
          <p:nvPr/>
        </p:nvSpPr>
        <p:spPr>
          <a:xfrm>
            <a:off x="3793680" y="606420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I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793320" y="58690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D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805920" y="567540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M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805920" y="546876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M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805920" y="527220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J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805920" y="507852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J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819240" y="488304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I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3805920" y="467676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F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3805920" y="447984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F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793320" y="42861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D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819240" y="40910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L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819240" y="388476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L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769560" y="36910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K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769560" y="34941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K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844440" y="3300480"/>
            <a:ext cx="1105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Lepus_timid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3612600" y="30942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N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612600" y="28987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N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638160" y="270360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E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3638160" y="250812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E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3674520" y="23018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H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674520" y="21081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H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4100040" y="1779480"/>
            <a:ext cx="1262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Lepus_europae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844160" y="15112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B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4844160" y="131616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4B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3870000" y="1052640"/>
            <a:ext cx="1602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Oryctolagus_cunicul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757680" y="61452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757680" y="595008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V="1">
            <a:off x="3757680" y="5950080"/>
            <a:ext cx="3240" cy="19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3784680" y="496260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784680" y="475632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V="1">
            <a:off x="3784680" y="4755960"/>
            <a:ext cx="1440" cy="20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784680" y="485928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3784680" y="456084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3784680" y="4560480"/>
            <a:ext cx="1440" cy="29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784680" y="515952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784680" y="47116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3784680" y="4711680"/>
            <a:ext cx="1440" cy="44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784680" y="535320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3784680" y="49276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3784680" y="4927680"/>
            <a:ext cx="1440" cy="425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3770280" y="554688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770280" y="5146560"/>
            <a:ext cx="14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 flipV="1">
            <a:off x="3770280" y="5146560"/>
            <a:ext cx="3240" cy="400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3770280" y="575316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3770280" y="53532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 flipV="1">
            <a:off x="3770280" y="5352840"/>
            <a:ext cx="3240" cy="39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3757680" y="5546880"/>
            <a:ext cx="1260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757680" y="436716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V="1">
            <a:off x="3757680" y="4366800"/>
            <a:ext cx="3240" cy="1179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3757680" y="604188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3757680" y="49514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3757680" y="4951080"/>
            <a:ext cx="3240" cy="1090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3784680" y="417204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3784680" y="396540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3784680" y="3965400"/>
            <a:ext cx="1440" cy="206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757680" y="55022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3757680" y="4068720"/>
            <a:ext cx="270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3757680" y="4068720"/>
            <a:ext cx="324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735360" y="377028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735360" y="357516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 flipV="1">
            <a:off x="3735360" y="3575160"/>
            <a:ext cx="1440" cy="19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3735360" y="4780080"/>
            <a:ext cx="223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735360" y="367812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flipV="1">
            <a:off x="3735360" y="3677760"/>
            <a:ext cx="1440" cy="110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578400" y="317484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578400" y="29782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 flipV="1">
            <a:off x="3578400" y="2978280"/>
            <a:ext cx="144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613320" y="2784600"/>
            <a:ext cx="2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613320" y="2589120"/>
            <a:ext cx="28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flipV="1">
            <a:off x="3613320" y="2588760"/>
            <a:ext cx="2880" cy="195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638520" y="238284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638520" y="21859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flipV="1">
            <a:off x="3638520" y="2185560"/>
            <a:ext cx="3240" cy="19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613320" y="2681280"/>
            <a:ext cx="2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613320" y="2290680"/>
            <a:ext cx="252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 flipV="1">
            <a:off x="3613320" y="2290320"/>
            <a:ext cx="2880" cy="390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578400" y="308124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578400" y="2486160"/>
            <a:ext cx="34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 flipV="1">
            <a:off x="3578400" y="2485800"/>
            <a:ext cx="1440" cy="595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216240" y="3381480"/>
            <a:ext cx="590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216240" y="2784600"/>
            <a:ext cx="362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flipV="1">
            <a:off x="3216240" y="2784600"/>
            <a:ext cx="1800" cy="59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203640" y="4229280"/>
            <a:ext cx="531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203640" y="3081240"/>
            <a:ext cx="12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V="1">
            <a:off x="3203640" y="3080880"/>
            <a:ext cx="1440" cy="114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4060800" y="199224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4060800" y="179856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203640" y="3656160"/>
            <a:ext cx="14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203640" y="1889280"/>
            <a:ext cx="857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flipV="1">
            <a:off x="3203640" y="1889280"/>
            <a:ext cx="1440" cy="176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4809960" y="159228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4809960" y="1395360"/>
            <a:ext cx="1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flipV="1">
            <a:off x="4809960" y="1395000"/>
            <a:ext cx="1800" cy="19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179880" y="2771640"/>
            <a:ext cx="23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179880" y="1498680"/>
            <a:ext cx="1630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flipV="1">
            <a:off x="3179880" y="1498680"/>
            <a:ext cx="1440" cy="127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1816200" y="2130480"/>
            <a:ext cx="1363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816200" y="1200240"/>
            <a:ext cx="20271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 flipV="1">
            <a:off x="1816200" y="1200240"/>
            <a:ext cx="1440" cy="930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9" name=""/>
          <p:cNvGrpSpPr/>
          <p:nvPr/>
        </p:nvGrpSpPr>
        <p:grpSpPr>
          <a:xfrm>
            <a:off x="1547640" y="5661000"/>
            <a:ext cx="581040" cy="326520"/>
            <a:chOff x="1547640" y="5661000"/>
            <a:chExt cx="581040" cy="326520"/>
          </a:xfrm>
        </p:grpSpPr>
        <p:sp>
          <p:nvSpPr>
            <p:cNvPr id="260" name=""/>
            <p:cNvSpPr/>
            <p:nvPr/>
          </p:nvSpPr>
          <p:spPr>
            <a:xfrm>
              <a:off x="1547640" y="5943600"/>
              <a:ext cx="579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flipV="1">
              <a:off x="1547640" y="5897160"/>
              <a:ext cx="180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2127240" y="5897160"/>
              <a:ext cx="144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683720" y="566100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4" name=""/>
          <p:cNvSpPr/>
          <p:nvPr/>
        </p:nvSpPr>
        <p:spPr>
          <a:xfrm>
            <a:off x="6412680" y="1268280"/>
            <a:ext cx="20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Lepus american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6447600" y="2492280"/>
            <a:ext cx="20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Lepus granaten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6447600" y="4646520"/>
            <a:ext cx="20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Lepus granaten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6084720" y="1268280"/>
            <a:ext cx="0" cy="43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6084720" y="3571920"/>
            <a:ext cx="0" cy="2665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5940360" y="62373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5940360" y="35719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6084720" y="2060640"/>
            <a:ext cx="0" cy="1152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5940360" y="32130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5940360" y="2060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5940360" y="17002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5940360" y="12682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396720" y="3333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2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"/>
          <p:cNvSpPr/>
          <p:nvPr/>
        </p:nvSpPr>
        <p:spPr>
          <a:xfrm>
            <a:off x="3979080" y="61642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G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979800" y="6018120"/>
            <a:ext cx="592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F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3978720" y="588492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F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979440" y="573732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E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979440" y="560232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E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979080" y="545796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C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979080" y="532116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C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979080" y="517536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B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979080" y="504180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B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979080" y="48942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A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979080" y="47610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A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979080" y="461484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R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3979080" y="448164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R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4103280" y="43340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L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103280" y="41990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L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4102920" y="40543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K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102920" y="39211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K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041000" y="377208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J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041000" y="363996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J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981600" y="3490920"/>
            <a:ext cx="1486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Ciona_intestinalis_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3940920" y="33591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G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3928680" y="321156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I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928680" y="307980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I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3969000" y="2930400"/>
            <a:ext cx="147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Ciona_intestinalis_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989880" y="279864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P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989880" y="265104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P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3966480" y="25178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N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3966480" y="23684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N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3989880" y="223668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M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3989880" y="208908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M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028760" y="195588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L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4028760" y="180828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L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3990240" y="16765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N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3990240" y="15271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N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989880" y="139536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M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989880" y="1247760"/>
            <a:ext cx="61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2M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990240" y="11145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G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990240" y="9651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G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4028040" y="83340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J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4028040" y="68580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J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4115520" y="5526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Q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4115520" y="4046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02Q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3941640" y="47084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3941640" y="45734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V="1">
            <a:off x="3941640" y="4573080"/>
            <a:ext cx="3240" cy="13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941640" y="485460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941640" y="46404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 flipV="1">
            <a:off x="3941640" y="4640040"/>
            <a:ext cx="3240" cy="214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941640" y="498960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941640" y="47480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flipV="1">
            <a:off x="3941640" y="4747680"/>
            <a:ext cx="3240" cy="241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941640" y="513540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941640" y="48690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V="1">
            <a:off x="3941640" y="4869000"/>
            <a:ext cx="3240" cy="266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941640" y="527040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941640" y="500076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 flipV="1">
            <a:off x="3941640" y="5000400"/>
            <a:ext cx="3240" cy="269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941640" y="54165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941640" y="513540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 flipV="1">
            <a:off x="3941640" y="5135040"/>
            <a:ext cx="3240" cy="281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3941640" y="55515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3941640" y="528156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 flipV="1">
            <a:off x="3941640" y="5281560"/>
            <a:ext cx="3240" cy="270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941640" y="569736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941640" y="54165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 flipV="1">
            <a:off x="3941640" y="5416560"/>
            <a:ext cx="3240" cy="28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941640" y="58309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941640" y="55515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flipV="1">
            <a:off x="3941640" y="5551560"/>
            <a:ext cx="324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3941640" y="597708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3941640" y="569736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 flipV="1">
            <a:off x="3941640" y="5697000"/>
            <a:ext cx="3240" cy="279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3941640" y="61117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3941640" y="58309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 flipV="1">
            <a:off x="3941640" y="5830920"/>
            <a:ext cx="3240" cy="28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3941640" y="625788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3941640" y="597708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 flipV="1">
            <a:off x="3941640" y="5977080"/>
            <a:ext cx="3240" cy="28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4079880" y="41482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4079880" y="401328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 flipV="1">
            <a:off x="4079880" y="4012920"/>
            <a:ext cx="1440" cy="13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4079880" y="429408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4079880" y="408132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 flipV="1">
            <a:off x="4079880" y="4080960"/>
            <a:ext cx="1440" cy="212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4079880" y="442764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4079880" y="41878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 flipV="1">
            <a:off x="4079880" y="4187880"/>
            <a:ext cx="144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4003560" y="38671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4003560" y="37321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 flipV="1">
            <a:off x="4003560" y="3731760"/>
            <a:ext cx="3240" cy="13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4003560" y="4308480"/>
            <a:ext cx="763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4003560" y="38005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 flipV="1">
            <a:off x="4003560" y="3800160"/>
            <a:ext cx="3240" cy="507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3941640" y="61117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3941640" y="4054320"/>
            <a:ext cx="61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 flipV="1">
            <a:off x="3941640" y="4053960"/>
            <a:ext cx="3240" cy="20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3941640" y="50817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3941640" y="358632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 flipV="1">
            <a:off x="3941640" y="3586320"/>
            <a:ext cx="3240" cy="1495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3905280" y="4334040"/>
            <a:ext cx="36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3905280" y="345132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 flipV="1">
            <a:off x="3905280" y="3451320"/>
            <a:ext cx="1440" cy="88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3905280" y="330516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3905280" y="31719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 flipV="1">
            <a:off x="3905280" y="3171960"/>
            <a:ext cx="1440" cy="133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3967200" y="289080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3967200" y="274464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 flipV="1">
            <a:off x="3967200" y="2744640"/>
            <a:ext cx="144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3929040" y="3024360"/>
            <a:ext cx="144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3929040" y="2809800"/>
            <a:ext cx="38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 flipV="1">
            <a:off x="3929040" y="2809800"/>
            <a:ext cx="1440" cy="21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3967200" y="232884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3967200" y="21844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 flipV="1">
            <a:off x="3967200" y="2184120"/>
            <a:ext cx="144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3929040" y="246384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3929040" y="2249640"/>
            <a:ext cx="3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 flipV="1">
            <a:off x="3929040" y="2249280"/>
            <a:ext cx="1440" cy="214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3929040" y="2610000"/>
            <a:ext cx="14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3929040" y="235728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 flipV="1">
            <a:off x="3929040" y="2357280"/>
            <a:ext cx="1440" cy="25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3990960" y="2048040"/>
            <a:ext cx="14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3990960" y="190188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 flipV="1">
            <a:off x="3990960" y="1901880"/>
            <a:ext cx="144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3929040" y="247824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3929040" y="1969920"/>
            <a:ext cx="61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 flipV="1">
            <a:off x="3929040" y="1969920"/>
            <a:ext cx="1440" cy="508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3967200" y="120636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967200" y="1060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 flipV="1">
            <a:off x="3967200" y="1060200"/>
            <a:ext cx="1440" cy="145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3967200" y="134136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3967200" y="11271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 flipV="1">
            <a:off x="3967200" y="1126800"/>
            <a:ext cx="1440" cy="214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3967200" y="148752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967200" y="12351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 flipV="1">
            <a:off x="3967200" y="1234800"/>
            <a:ext cx="1440" cy="252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3967200" y="1620720"/>
            <a:ext cx="1440" cy="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3967200" y="13557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 flipV="1">
            <a:off x="3967200" y="1355760"/>
            <a:ext cx="1440" cy="264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3967200" y="176832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3967200" y="148752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 flipV="1">
            <a:off x="3967200" y="1487520"/>
            <a:ext cx="1440" cy="28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3990960" y="92700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3990960" y="78120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 flipV="1">
            <a:off x="3990960" y="780840"/>
            <a:ext cx="1440" cy="145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3967200" y="1620720"/>
            <a:ext cx="1440" cy="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3967200" y="846000"/>
            <a:ext cx="23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 flipV="1">
            <a:off x="3967200" y="846000"/>
            <a:ext cx="1440" cy="77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4092480" y="644400"/>
            <a:ext cx="18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4092480" y="498600"/>
            <a:ext cx="180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 flipV="1">
            <a:off x="4092480" y="498240"/>
            <a:ext cx="1800" cy="145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3929040" y="1235160"/>
            <a:ext cx="38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3929040" y="566640"/>
            <a:ext cx="163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 flipV="1">
            <a:off x="3929040" y="566280"/>
            <a:ext cx="1440" cy="668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3929040" y="22240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3929040" y="90000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 flipV="1">
            <a:off x="3929040" y="900000"/>
            <a:ext cx="1440" cy="1324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3929040" y="2917800"/>
            <a:ext cx="144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3929040" y="156852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 flipV="1">
            <a:off x="3929040" y="1568520"/>
            <a:ext cx="1440" cy="134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3905280" y="3238560"/>
            <a:ext cx="144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3905280" y="2249640"/>
            <a:ext cx="23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 flipV="1">
            <a:off x="3905280" y="2249280"/>
            <a:ext cx="1440" cy="9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1476360" y="3892680"/>
            <a:ext cx="2428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1476360" y="2744640"/>
            <a:ext cx="2428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 flipV="1">
            <a:off x="1476360" y="2744280"/>
            <a:ext cx="1440" cy="114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5958720" y="1674720"/>
            <a:ext cx="21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Ciona intestinalis</a:t>
            </a: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5977800" y="4635360"/>
            <a:ext cx="21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Ciona intestinalis</a:t>
            </a: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5724360" y="487440"/>
            <a:ext cx="0" cy="2827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5724360" y="3478320"/>
            <a:ext cx="0" cy="2827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5580000" y="63054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5580000" y="34783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5580000" y="33148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5580000" y="4874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0" name=""/>
          <p:cNvGrpSpPr/>
          <p:nvPr/>
        </p:nvGrpSpPr>
        <p:grpSpPr>
          <a:xfrm>
            <a:off x="1619280" y="5445000"/>
            <a:ext cx="482040" cy="378000"/>
            <a:chOff x="1619280" y="5445000"/>
            <a:chExt cx="482040" cy="378000"/>
          </a:xfrm>
        </p:grpSpPr>
        <p:sp>
          <p:nvSpPr>
            <p:cNvPr id="451" name=""/>
            <p:cNvSpPr/>
            <p:nvPr/>
          </p:nvSpPr>
          <p:spPr>
            <a:xfrm>
              <a:off x="1668240" y="5776920"/>
              <a:ext cx="43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1619280" y="5445000"/>
              <a:ext cx="47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 flipV="1">
              <a:off x="1666440" y="5732280"/>
              <a:ext cx="1440" cy="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 flipV="1">
              <a:off x="2099880" y="5732280"/>
              <a:ext cx="1440" cy="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5" name=""/>
          <p:cNvSpPr/>
          <p:nvPr/>
        </p:nvSpPr>
        <p:spPr>
          <a:xfrm>
            <a:off x="397080" y="3333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2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"/>
          <p:cNvSpPr/>
          <p:nvPr/>
        </p:nvSpPr>
        <p:spPr>
          <a:xfrm>
            <a:off x="2536560" y="159552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L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3023640" y="13780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K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3023640" y="11476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K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4065120" y="932040"/>
            <a:ext cx="164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Reticulitermes_flavip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3024000" y="71280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L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3067920" y="5958000"/>
            <a:ext cx="1585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Reticulitermes_grasse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3063240" y="57405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A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3063600" y="552276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E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3063600" y="529272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I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3063600" y="507348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I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3063240" y="48560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H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3063240" y="46404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H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3063240" y="44100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G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3063240" y="41893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G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3062880" y="397368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F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3062880" y="375588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F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3063600" y="35258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E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3063240" y="33084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A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3063240" y="30891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D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3063240" y="28735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D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3062880" y="26416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C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3062880" y="24256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C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3062880" y="220680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B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3062880" y="198900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5B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3035160" y="60483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3035160" y="58309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 flipV="1">
            <a:off x="3035160" y="5830920"/>
            <a:ext cx="3240" cy="217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3035160" y="593244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3035160" y="561168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 flipV="1">
            <a:off x="3035160" y="5611320"/>
            <a:ext cx="3240" cy="32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3035160" y="576576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3035160" y="538164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 flipV="1">
            <a:off x="3035160" y="5381280"/>
            <a:ext cx="3240" cy="38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3035160" y="361620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3035160" y="33973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 flipV="1">
            <a:off x="3035160" y="3397320"/>
            <a:ext cx="3240" cy="218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3035160" y="384660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3035160" y="35114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 flipV="1">
            <a:off x="3035160" y="3511080"/>
            <a:ext cx="3240" cy="335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3035160" y="406404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3035160" y="36799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 flipV="1">
            <a:off x="3035160" y="3679560"/>
            <a:ext cx="3240" cy="38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3035160" y="428004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3035160" y="387180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 flipV="1">
            <a:off x="3035160" y="3871800"/>
            <a:ext cx="3240" cy="40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3035160" y="449748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3035160" y="40752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 flipV="1">
            <a:off x="3035160" y="4074840"/>
            <a:ext cx="3240" cy="42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3035160" y="47275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3035160" y="429408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 flipV="1">
            <a:off x="3035160" y="4294080"/>
            <a:ext cx="3240" cy="433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3035160" y="494676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3035160" y="451152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 flipV="1">
            <a:off x="3035160" y="4511160"/>
            <a:ext cx="3240" cy="435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3035160" y="51642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3035160" y="472752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 flipV="1">
            <a:off x="3035160" y="4727160"/>
            <a:ext cx="3240" cy="436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3035160" y="557388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3035160" y="494676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 flipV="1">
            <a:off x="3035160" y="4946760"/>
            <a:ext cx="3240" cy="62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3035160" y="52657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3035160" y="317988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 flipV="1">
            <a:off x="3035160" y="3179880"/>
            <a:ext cx="3240" cy="208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3035160" y="42181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3035160" y="296388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 flipV="1">
            <a:off x="3035160" y="2963880"/>
            <a:ext cx="3240" cy="1254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3035160" y="358920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3035160" y="273204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 flipV="1">
            <a:off x="3035160" y="2731680"/>
            <a:ext cx="3240" cy="857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3035160" y="316692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3035160" y="251316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 flipV="1">
            <a:off x="3035160" y="2513160"/>
            <a:ext cx="3240" cy="65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3035160" y="283356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3035160" y="229716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 flipV="1">
            <a:off x="3035160" y="2297160"/>
            <a:ext cx="3240" cy="536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3035160" y="256536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3035160" y="207972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 flipV="1">
            <a:off x="3035160" y="2079360"/>
            <a:ext cx="3240" cy="48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2743200" y="2298600"/>
            <a:ext cx="2919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2997360" y="1019160"/>
            <a:ext cx="10252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2997360" y="803160"/>
            <a:ext cx="28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 flipV="1">
            <a:off x="2997360" y="803160"/>
            <a:ext cx="2880" cy="21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2997360" y="1238400"/>
            <a:ext cx="288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2997360" y="917640"/>
            <a:ext cx="28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 flipV="1">
            <a:off x="2997360" y="917280"/>
            <a:ext cx="2880" cy="32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2997360" y="1468440"/>
            <a:ext cx="28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2997360" y="1084320"/>
            <a:ext cx="28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 flipV="1">
            <a:off x="2997360" y="1083960"/>
            <a:ext cx="2880" cy="38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2511360" y="1685880"/>
            <a:ext cx="32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2511360" y="1276200"/>
            <a:ext cx="4860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 flipV="1">
            <a:off x="2511360" y="1276200"/>
            <a:ext cx="3240" cy="409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1793880" y="2300400"/>
            <a:ext cx="9493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1793880" y="1481040"/>
            <a:ext cx="7174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 flipV="1">
            <a:off x="1793880" y="1481040"/>
            <a:ext cx="1440" cy="81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0" name=""/>
          <p:cNvGrpSpPr/>
          <p:nvPr/>
        </p:nvGrpSpPr>
        <p:grpSpPr>
          <a:xfrm>
            <a:off x="1403280" y="5373720"/>
            <a:ext cx="487440" cy="301680"/>
            <a:chOff x="1403280" y="5373720"/>
            <a:chExt cx="487440" cy="301680"/>
          </a:xfrm>
        </p:grpSpPr>
        <p:sp>
          <p:nvSpPr>
            <p:cNvPr id="551" name=""/>
            <p:cNvSpPr/>
            <p:nvPr/>
          </p:nvSpPr>
          <p:spPr>
            <a:xfrm>
              <a:off x="1403280" y="5626080"/>
              <a:ext cx="4856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 flipV="1">
              <a:off x="1403280" y="5573880"/>
              <a:ext cx="144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 flipV="1">
              <a:off x="1888920" y="5573880"/>
              <a:ext cx="180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1504440" y="5373720"/>
              <a:ext cx="267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5" name=""/>
          <p:cNvSpPr/>
          <p:nvPr/>
        </p:nvSpPr>
        <p:spPr>
          <a:xfrm>
            <a:off x="6093720" y="1046160"/>
            <a:ext cx="246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Reticulitermes flavip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6012000" y="765000"/>
            <a:ext cx="0" cy="935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5867280" y="170028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5867280" y="76500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6174720" y="371016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Reticulitermes grasse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6012000" y="1916280"/>
            <a:ext cx="0" cy="424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5867280" y="616428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5867280" y="191628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396720" y="3333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2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4" name=""/>
          <p:cNvSpPr/>
          <p:nvPr/>
        </p:nvSpPr>
        <p:spPr>
          <a:xfrm>
            <a:off x="4191840" y="633420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J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4204440" y="612144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C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4204440" y="59086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C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4191840" y="5681520"/>
            <a:ext cx="53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J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4194720" y="5467320"/>
            <a:ext cx="103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Ostrea_edul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4191840" y="525456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D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4191840" y="504180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D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4204440" y="48164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A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4204440" y="46004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A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4204440" y="43876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B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4204440" y="4175280"/>
            <a:ext cx="58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B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4215960" y="394956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I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4215960" y="3736800"/>
            <a:ext cx="52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I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4246920" y="352116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F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4246920" y="3308400"/>
            <a:ext cx="56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F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4257000" y="308304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H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4257000" y="287028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H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4257000" y="26557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G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4257000" y="24415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G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4257360" y="221616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E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4257360" y="200340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E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4174560" y="1789200"/>
            <a:ext cx="1204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ff"/>
                </a:solidFill>
                <a:latin typeface="Times New Roman"/>
              </a:rPr>
              <a:t>ref|Ostrea_chilen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4236840" y="157644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L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4236840" y="1349280"/>
            <a:ext cx="57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L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4236480" y="11365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K|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>
            <a:off x="4236480" y="922320"/>
            <a:ext cx="588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A14K|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4172040" y="62103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4172040" y="599436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 flipV="1">
            <a:off x="4172040" y="5994360"/>
            <a:ext cx="1440" cy="21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4172040" y="642312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4172040" y="609588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 flipV="1">
            <a:off x="4172040" y="6095520"/>
            <a:ext cx="1440" cy="327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4172040" y="625788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4172040" y="576900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 flipV="1">
            <a:off x="4172040" y="5769000"/>
            <a:ext cx="1440" cy="488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4172040" y="60213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4172040" y="555624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 flipV="1">
            <a:off x="4172040" y="5556240"/>
            <a:ext cx="1440" cy="46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4172040" y="534348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4172040" y="512748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 flipV="1">
            <a:off x="4172040" y="5127480"/>
            <a:ext cx="1440" cy="21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4160880" y="5781600"/>
            <a:ext cx="111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4160880" y="5230800"/>
            <a:ext cx="11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 flipV="1">
            <a:off x="4160880" y="5230800"/>
            <a:ext cx="1440" cy="550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4183200" y="4902120"/>
            <a:ext cx="28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4183200" y="4689360"/>
            <a:ext cx="28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 flipV="1">
            <a:off x="4183200" y="4689000"/>
            <a:ext cx="2880" cy="212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4160880" y="55054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4160880" y="4802040"/>
            <a:ext cx="223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 flipV="1">
            <a:off x="4160880" y="4802040"/>
            <a:ext cx="1440" cy="703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4172040" y="447660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4172040" y="426420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 flipV="1">
            <a:off x="4172040" y="4264200"/>
            <a:ext cx="1440" cy="212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4192560" y="4038480"/>
            <a:ext cx="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4192560" y="3822840"/>
            <a:ext cx="324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 flipV="1">
            <a:off x="4192560" y="3822480"/>
            <a:ext cx="3240" cy="21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4160880" y="4363920"/>
            <a:ext cx="11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4160880" y="3935520"/>
            <a:ext cx="316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 flipV="1">
            <a:off x="4160880" y="3935520"/>
            <a:ext cx="1440" cy="428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4151160" y="5154480"/>
            <a:ext cx="97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4151160" y="4151160"/>
            <a:ext cx="9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 flipV="1">
            <a:off x="4151160" y="4150800"/>
            <a:ext cx="1800" cy="1003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4216320" y="3610080"/>
            <a:ext cx="18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4216320" y="3397320"/>
            <a:ext cx="18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 flipV="1">
            <a:off x="4216320" y="3396960"/>
            <a:ext cx="1800" cy="212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4237200" y="274320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4237200" y="253044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 flipV="1">
            <a:off x="4237200" y="2530080"/>
            <a:ext cx="1440" cy="212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4237200" y="295596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4237200" y="263052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 flipV="1">
            <a:off x="4237200" y="2630520"/>
            <a:ext cx="1440" cy="325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4237200" y="31719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4237200" y="2793960"/>
            <a:ext cx="1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 flipV="1">
            <a:off x="4237200" y="2793960"/>
            <a:ext cx="1440" cy="37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4237200" y="23050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4237200" y="209088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 flipV="1">
            <a:off x="4237200" y="2090520"/>
            <a:ext cx="1440" cy="214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4226040" y="2982960"/>
            <a:ext cx="111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4226040" y="2203560"/>
            <a:ext cx="11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 flipV="1">
            <a:off x="4226040" y="2203200"/>
            <a:ext cx="1440" cy="77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4216320" y="349740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4216320" y="2592360"/>
            <a:ext cx="97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 flipV="1">
            <a:off x="4216320" y="2592360"/>
            <a:ext cx="1800" cy="90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4151160" y="4651200"/>
            <a:ext cx="18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4151160" y="3044880"/>
            <a:ext cx="651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 flipV="1">
            <a:off x="4151160" y="3044880"/>
            <a:ext cx="1800" cy="160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4205160" y="122400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4205160" y="101124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 flipV="1">
            <a:off x="4205160" y="1010880"/>
            <a:ext cx="1800" cy="212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4205160" y="1438200"/>
            <a:ext cx="18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4205160" y="112392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 flipV="1">
            <a:off x="4205160" y="1123560"/>
            <a:ext cx="1800" cy="31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4205160" y="16653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4205160" y="1287360"/>
            <a:ext cx="180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 flipV="1">
            <a:off x="4205160" y="1287360"/>
            <a:ext cx="1800" cy="37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4129200" y="1878120"/>
            <a:ext cx="11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4129200" y="1476360"/>
            <a:ext cx="75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 flipV="1">
            <a:off x="4129200" y="1476360"/>
            <a:ext cx="1440" cy="40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1793880" y="3849840"/>
            <a:ext cx="2357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1793880" y="1674720"/>
            <a:ext cx="23353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 flipV="1">
            <a:off x="1793880" y="1674720"/>
            <a:ext cx="1440" cy="2175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5" name=""/>
          <p:cNvGrpSpPr/>
          <p:nvPr/>
        </p:nvGrpSpPr>
        <p:grpSpPr>
          <a:xfrm>
            <a:off x="1619280" y="5373720"/>
            <a:ext cx="704880" cy="297000"/>
            <a:chOff x="1619280" y="5373720"/>
            <a:chExt cx="704880" cy="297000"/>
          </a:xfrm>
        </p:grpSpPr>
        <p:sp>
          <p:nvSpPr>
            <p:cNvPr id="666" name=""/>
            <p:cNvSpPr/>
            <p:nvPr/>
          </p:nvSpPr>
          <p:spPr>
            <a:xfrm>
              <a:off x="1619280" y="5623200"/>
              <a:ext cx="703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"/>
            <p:cNvSpPr/>
            <p:nvPr/>
          </p:nvSpPr>
          <p:spPr>
            <a:xfrm flipV="1">
              <a:off x="1619280" y="5572080"/>
              <a:ext cx="1800" cy="9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"/>
            <p:cNvSpPr/>
            <p:nvPr/>
          </p:nvSpPr>
          <p:spPr>
            <a:xfrm flipV="1">
              <a:off x="2322720" y="5572080"/>
              <a:ext cx="1440" cy="9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"/>
            <p:cNvSpPr/>
            <p:nvPr/>
          </p:nvSpPr>
          <p:spPr>
            <a:xfrm>
              <a:off x="1834920" y="537372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0" name=""/>
          <p:cNvSpPr/>
          <p:nvPr/>
        </p:nvSpPr>
        <p:spPr>
          <a:xfrm>
            <a:off x="6495840" y="1268280"/>
            <a:ext cx="180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Ostrea chilen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6084720" y="981000"/>
            <a:ext cx="0" cy="935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5940360" y="19162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>
            <a:off x="5940360" y="9810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6638400" y="3860640"/>
            <a:ext cx="147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800" spc="-1" strike="noStrike">
                <a:solidFill>
                  <a:srgbClr val="000000"/>
                </a:solidFill>
                <a:latin typeface="Arial"/>
              </a:rPr>
              <a:t>Ostrea edu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6084720" y="2060640"/>
            <a:ext cx="0" cy="439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5940360" y="64533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5940360" y="2060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397080" y="3333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2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26T15:17:04Z</dcterms:created>
  <dc:creator>GALTIER</dc:creator>
  <dc:description/>
  <dc:language>en-US</dc:language>
  <cp:lastModifiedBy>GALTIER</cp:lastModifiedBy>
  <dcterms:modified xsi:type="dcterms:W3CDTF">2012-12-29T23:12:47Z</dcterms:modified>
  <cp:revision>107</cp:revision>
  <dc:subject/>
  <dc:title>Diapositive 1</dc:title>
</cp:coreProperties>
</file>